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7"/>
  </p:notesMasterIdLst>
  <p:handoutMasterIdLst>
    <p:handoutMasterId r:id="rId8"/>
  </p:handoutMasterIdLst>
  <p:sldIdLst>
    <p:sldId id="321" r:id="rId2"/>
    <p:sldId id="323" r:id="rId3"/>
    <p:sldId id="325" r:id="rId4"/>
    <p:sldId id="322" r:id="rId5"/>
    <p:sldId id="324" r:id="rId6"/>
  </p:sldIdLst>
  <p:sldSz cx="7772400" cy="10058400"/>
  <p:notesSz cx="7026275" cy="9312275"/>
  <p:defaultTextStyle>
    <a:defPPr>
      <a:defRPr lang="en-US"/>
    </a:defPPr>
    <a:lvl1pPr marL="0" algn="l" defTabSz="1018705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1pPr>
    <a:lvl2pPr marL="509352" algn="l" defTabSz="1018705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2pPr>
    <a:lvl3pPr marL="1018705" algn="l" defTabSz="1018705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3pPr>
    <a:lvl4pPr marL="1528058" algn="l" defTabSz="1018705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4pPr>
    <a:lvl5pPr marL="2037411" algn="l" defTabSz="1018705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5pPr>
    <a:lvl6pPr marL="2546764" algn="l" defTabSz="1018705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6pPr>
    <a:lvl7pPr marL="3056116" algn="l" defTabSz="1018705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7pPr>
    <a:lvl8pPr marL="3565469" algn="l" defTabSz="1018705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8pPr>
    <a:lvl9pPr marL="4074821" algn="l" defTabSz="1018705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3733"/>
    <a:srgbClr val="FF0000"/>
    <a:srgbClr val="FF4747"/>
    <a:srgbClr val="FF3300"/>
    <a:srgbClr val="3399FF"/>
    <a:srgbClr val="FF9999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7063" autoAdjust="0"/>
    <p:restoredTop sz="94660"/>
  </p:normalViewPr>
  <p:slideViewPr>
    <p:cSldViewPr snapToGrid="0">
      <p:cViewPr varScale="1">
        <p:scale>
          <a:sx n="75" d="100"/>
          <a:sy n="75" d="100"/>
        </p:scale>
        <p:origin x="1758" y="6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4720" cy="467231"/>
          </a:xfrm>
          <a:prstGeom prst="rect">
            <a:avLst/>
          </a:prstGeom>
        </p:spPr>
        <p:txBody>
          <a:bodyPr vert="horz" lIns="93352" tIns="46677" rIns="93352" bIns="466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9930" y="0"/>
            <a:ext cx="3044720" cy="467231"/>
          </a:xfrm>
          <a:prstGeom prst="rect">
            <a:avLst/>
          </a:prstGeom>
        </p:spPr>
        <p:txBody>
          <a:bodyPr vert="horz" lIns="93352" tIns="46677" rIns="93352" bIns="46677" rtlCol="0"/>
          <a:lstStyle>
            <a:lvl1pPr algn="r">
              <a:defRPr sz="1200"/>
            </a:lvl1pPr>
          </a:lstStyle>
          <a:p>
            <a:fld id="{F84B859D-2EA2-4CA2-8CB3-98B705F1EE6E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45046"/>
            <a:ext cx="3044720" cy="467230"/>
          </a:xfrm>
          <a:prstGeom prst="rect">
            <a:avLst/>
          </a:prstGeom>
        </p:spPr>
        <p:txBody>
          <a:bodyPr vert="horz" lIns="93352" tIns="46677" rIns="93352" bIns="466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9930" y="8845046"/>
            <a:ext cx="3044720" cy="467230"/>
          </a:xfrm>
          <a:prstGeom prst="rect">
            <a:avLst/>
          </a:prstGeom>
        </p:spPr>
        <p:txBody>
          <a:bodyPr vert="horz" lIns="93352" tIns="46677" rIns="93352" bIns="46677" rtlCol="0" anchor="b"/>
          <a:lstStyle>
            <a:lvl1pPr algn="r">
              <a:defRPr sz="1200"/>
            </a:lvl1pPr>
          </a:lstStyle>
          <a:p>
            <a:fld id="{883F4305-74B0-45DA-A19D-2B5110F33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6360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44401" cy="467043"/>
          </a:xfrm>
          <a:prstGeom prst="rect">
            <a:avLst/>
          </a:prstGeom>
        </p:spPr>
        <p:txBody>
          <a:bodyPr vert="horz" lIns="91504" tIns="45752" rIns="91504" bIns="4575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80285" y="1"/>
            <a:ext cx="3044401" cy="467043"/>
          </a:xfrm>
          <a:prstGeom prst="rect">
            <a:avLst/>
          </a:prstGeom>
        </p:spPr>
        <p:txBody>
          <a:bodyPr vert="horz" lIns="91504" tIns="45752" rIns="91504" bIns="45752" rtlCol="0"/>
          <a:lstStyle>
            <a:lvl1pPr algn="r">
              <a:defRPr sz="1200"/>
            </a:lvl1pPr>
          </a:lstStyle>
          <a:p>
            <a:fld id="{3FED7707-5926-43B7-BD52-C51EB96121F5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0288" y="1165225"/>
            <a:ext cx="2425700" cy="31416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04" tIns="45752" rIns="91504" bIns="4575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1394"/>
            <a:ext cx="5621656" cy="3666450"/>
          </a:xfrm>
          <a:prstGeom prst="rect">
            <a:avLst/>
          </a:prstGeom>
        </p:spPr>
        <p:txBody>
          <a:bodyPr vert="horz" lIns="91504" tIns="45752" rIns="91504" bIns="4575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5232"/>
            <a:ext cx="3044401" cy="467043"/>
          </a:xfrm>
          <a:prstGeom prst="rect">
            <a:avLst/>
          </a:prstGeom>
        </p:spPr>
        <p:txBody>
          <a:bodyPr vert="horz" lIns="91504" tIns="45752" rIns="91504" bIns="4575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80285" y="8845232"/>
            <a:ext cx="3044401" cy="467043"/>
          </a:xfrm>
          <a:prstGeom prst="rect">
            <a:avLst/>
          </a:prstGeom>
        </p:spPr>
        <p:txBody>
          <a:bodyPr vert="horz" lIns="91504" tIns="45752" rIns="91504" bIns="45752" rtlCol="0" anchor="b"/>
          <a:lstStyle>
            <a:lvl1pPr algn="r">
              <a:defRPr sz="1200"/>
            </a:lvl1pPr>
          </a:lstStyle>
          <a:p>
            <a:fld id="{A2395155-0605-429E-9961-D78B0C44E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8236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705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1pPr>
    <a:lvl2pPr marL="509352" algn="l" defTabSz="1018705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2pPr>
    <a:lvl3pPr marL="1018705" algn="l" defTabSz="1018705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3pPr>
    <a:lvl4pPr marL="1528058" algn="l" defTabSz="1018705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4pPr>
    <a:lvl5pPr marL="2037411" algn="l" defTabSz="1018705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5pPr>
    <a:lvl6pPr marL="2546764" algn="l" defTabSz="1018705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6pPr>
    <a:lvl7pPr marL="3056116" algn="l" defTabSz="1018705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7pPr>
    <a:lvl8pPr marL="3565469" algn="l" defTabSz="1018705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8pPr>
    <a:lvl9pPr marL="4074821" algn="l" defTabSz="1018705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909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332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298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085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474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100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955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713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183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716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321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660199-6C85-4170-B461-0A1D7D4DC4CD}" type="datetimeFigureOut">
              <a:rPr lang="en-US" smtClean="0"/>
              <a:t>5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027580-7FE7-4738-8EC7-631952E32B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606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/>
          <p:cNvSpPr txBox="1">
            <a:spLocks/>
          </p:cNvSpPr>
          <p:nvPr/>
        </p:nvSpPr>
        <p:spPr>
          <a:xfrm>
            <a:off x="2991342" y="116689"/>
            <a:ext cx="1789717" cy="519728"/>
          </a:xfrm>
          <a:prstGeom prst="rect">
            <a:avLst/>
          </a:prstGeom>
        </p:spPr>
        <p:txBody>
          <a:bodyPr vert="horz" lIns="93681" tIns="46841" rIns="93681" bIns="4684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411480" y="866709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itle 1"/>
          <p:cNvSpPr txBox="1">
            <a:spLocks/>
          </p:cNvSpPr>
          <p:nvPr/>
        </p:nvSpPr>
        <p:spPr>
          <a:xfrm>
            <a:off x="3884648" y="866709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28" y="1137413"/>
            <a:ext cx="3474720" cy="229209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067663" y="1137413"/>
            <a:ext cx="1554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GF19 inhibitio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4648" y="1137413"/>
            <a:ext cx="3474720" cy="22920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15236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/>
          <p:cNvSpPr txBox="1">
            <a:spLocks/>
          </p:cNvSpPr>
          <p:nvPr/>
        </p:nvSpPr>
        <p:spPr>
          <a:xfrm>
            <a:off x="2991342" y="116689"/>
            <a:ext cx="1789717" cy="519728"/>
          </a:xfrm>
          <a:prstGeom prst="rect">
            <a:avLst/>
          </a:prstGeom>
        </p:spPr>
        <p:txBody>
          <a:bodyPr vert="horz" lIns="93681" tIns="46841" rIns="93681" bIns="4684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411480" y="866709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itle 1"/>
          <p:cNvSpPr txBox="1">
            <a:spLocks/>
          </p:cNvSpPr>
          <p:nvPr/>
        </p:nvSpPr>
        <p:spPr>
          <a:xfrm>
            <a:off x="3884648" y="866709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067663" y="1137413"/>
            <a:ext cx="1554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GF19 inhibitio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28" y="1137413"/>
            <a:ext cx="3474720" cy="229209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4648" y="1137413"/>
            <a:ext cx="3474720" cy="22920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41124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/>
          <p:cNvSpPr txBox="1">
            <a:spLocks/>
          </p:cNvSpPr>
          <p:nvPr/>
        </p:nvSpPr>
        <p:spPr>
          <a:xfrm>
            <a:off x="2991342" y="116689"/>
            <a:ext cx="1789717" cy="519728"/>
          </a:xfrm>
          <a:prstGeom prst="rect">
            <a:avLst/>
          </a:prstGeom>
        </p:spPr>
        <p:txBody>
          <a:bodyPr vert="horz" lIns="93681" tIns="46841" rIns="93681" bIns="4684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1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411480" y="911469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itle 1"/>
          <p:cNvSpPr txBox="1">
            <a:spLocks/>
          </p:cNvSpPr>
          <p:nvPr/>
        </p:nvSpPr>
        <p:spPr>
          <a:xfrm>
            <a:off x="455108" y="3854228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2719" y="1176591"/>
            <a:ext cx="3432797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096" y="4096981"/>
            <a:ext cx="3432797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" name="Group 2"/>
          <p:cNvGrpSpPr/>
          <p:nvPr/>
        </p:nvGrpSpPr>
        <p:grpSpPr>
          <a:xfrm>
            <a:off x="526134" y="1144807"/>
            <a:ext cx="2673330" cy="2286000"/>
            <a:chOff x="453403" y="3757508"/>
            <a:chExt cx="2673330" cy="2286000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3403" y="3757508"/>
              <a:ext cx="2673330" cy="228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1124528" y="4895289"/>
              <a:ext cx="2613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*</a:t>
              </a:r>
              <a:endParaRPr lang="en-US" sz="12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239214" y="5232306"/>
              <a:ext cx="2613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*</a:t>
              </a:r>
              <a:endParaRPr lang="en-US" sz="12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29328" y="5188899"/>
              <a:ext cx="2613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*</a:t>
              </a:r>
              <a:endParaRPr lang="en-US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928601" y="4753855"/>
              <a:ext cx="2613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*</a:t>
              </a:r>
              <a:endParaRPr lang="en-US" sz="1200" dirty="0"/>
            </a:p>
          </p:txBody>
        </p:sp>
      </p:grpSp>
      <p:sp>
        <p:nvSpPr>
          <p:cNvPr id="18" name="Title 1"/>
          <p:cNvSpPr txBox="1">
            <a:spLocks/>
          </p:cNvSpPr>
          <p:nvPr/>
        </p:nvSpPr>
        <p:spPr>
          <a:xfrm>
            <a:off x="3583683" y="890639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76921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/>
          <p:cNvSpPr txBox="1">
            <a:spLocks/>
          </p:cNvSpPr>
          <p:nvPr/>
        </p:nvSpPr>
        <p:spPr>
          <a:xfrm>
            <a:off x="2991342" y="116689"/>
            <a:ext cx="1789717" cy="519728"/>
          </a:xfrm>
          <a:prstGeom prst="rect">
            <a:avLst/>
          </a:prstGeom>
        </p:spPr>
        <p:txBody>
          <a:bodyPr vert="horz" lIns="93681" tIns="46841" rIns="93681" bIns="4684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US" sz="1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411480" y="866709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itle 1"/>
          <p:cNvSpPr txBox="1">
            <a:spLocks/>
          </p:cNvSpPr>
          <p:nvPr/>
        </p:nvSpPr>
        <p:spPr>
          <a:xfrm>
            <a:off x="3884648" y="866709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itle 1"/>
          <p:cNvSpPr txBox="1">
            <a:spLocks/>
          </p:cNvSpPr>
          <p:nvPr/>
        </p:nvSpPr>
        <p:spPr>
          <a:xfrm>
            <a:off x="411480" y="3564861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28" y="3835565"/>
            <a:ext cx="3474720" cy="22860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28" y="1135889"/>
            <a:ext cx="3474720" cy="228904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4648" y="1135889"/>
            <a:ext cx="3474720" cy="22890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7246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/>
          <p:cNvSpPr txBox="1">
            <a:spLocks/>
          </p:cNvSpPr>
          <p:nvPr/>
        </p:nvSpPr>
        <p:spPr>
          <a:xfrm>
            <a:off x="2991342" y="116689"/>
            <a:ext cx="1789717" cy="519728"/>
          </a:xfrm>
          <a:prstGeom prst="rect">
            <a:avLst/>
          </a:prstGeom>
        </p:spPr>
        <p:txBody>
          <a:bodyPr vert="horz" lIns="93681" tIns="46841" rIns="93681" bIns="4684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en-US" sz="1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411480" y="866709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itle 1"/>
          <p:cNvSpPr txBox="1">
            <a:spLocks/>
          </p:cNvSpPr>
          <p:nvPr/>
        </p:nvSpPr>
        <p:spPr>
          <a:xfrm>
            <a:off x="411480" y="4860001"/>
            <a:ext cx="339796" cy="270704"/>
          </a:xfrm>
          <a:prstGeom prst="rect">
            <a:avLst/>
          </a:prstGeom>
        </p:spPr>
        <p:txBody>
          <a:bodyPr vert="horz" lIns="70262" tIns="35131" rIns="70262" bIns="3513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276" y="1137413"/>
            <a:ext cx="6035040" cy="372258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276" y="5130705"/>
            <a:ext cx="6035040" cy="3813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23739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523</TotalTime>
  <Words>30</Words>
  <Application>Microsoft Office PowerPoint</Application>
  <PresentationFormat>Custom</PresentationFormat>
  <Paragraphs>2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Chitra G.</cp:lastModifiedBy>
  <cp:revision>1</cp:revision>
  <cp:lastPrinted>2017-10-25T18:52:03Z</cp:lastPrinted>
  <dcterms:modified xsi:type="dcterms:W3CDTF">2018-05-10T10:17:46Z</dcterms:modified>
</cp:coreProperties>
</file>